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4C49263-D3CB-4FE5-87F4-95B06B20142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58FC600-61E0-45BA-83FE-4CA226658D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BB11D39-3271-4578-B5B9-3628478D61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247EFF2-4CD6-40AC-B748-07B6BD3F396F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3FFC612-7B5E-4C45-A450-D480CCF402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1D85A74-52C0-4695-8D29-282C8AF1F9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F8BFB4-CB14-4B2C-8277-DFE7915D32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C9B8246-3766-4861-975E-90F20E8D23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AFC200F-BE14-4A22-8AC6-8517822995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500177D-8B03-44CE-B0C6-EB1B6EF1AC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469919D-0A6F-4D0D-9D2E-7EE0E662C1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F00D967-6DBB-48B1-8277-845C203652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6/27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B1737D8B-0F19-4614-92D6-48066B2434DA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260280" y="826920"/>
            <a:ext cx="2519280" cy="1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Times New Roman"/>
              </a:rPr>
              <a:t>TableS2 Gene-specific primers used in this study.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60280" y="1042920"/>
          <a:ext cx="6340320" cy="7159320"/>
        </p:xfrm>
        <a:graphic>
          <a:graphicData uri="http://schemas.openxmlformats.org/drawingml/2006/table">
            <a:tbl>
              <a:tblPr/>
              <a:tblGrid>
                <a:gridCol w="2016720"/>
                <a:gridCol w="1861200"/>
                <a:gridCol w="1860840"/>
                <a:gridCol w="601560"/>
              </a:tblGrid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 designation in this study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eft prime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ight prime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duct siz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S rRN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GATAACTCGACGGATC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TGGATGTGGTAGCCGT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 kDa oleosi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ACGCTGGCTACTCCTC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CTAAGAGGCGATCCTG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D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CAAGTTTCGACATGCT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ATGCCATATTTCCATG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188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SU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GTGTTGTGTGTGTGTGC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TGATGATGGAAGCTCAC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CIN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GTTTCAGCGGAAAAG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TCCATGCATTCAAAC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SUS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AGCGCATCGAGGAGAAG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CAATGGAACGGTGGT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SUS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CGTGAACTGGCGAAGA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CAAGTTCGTCACTTGC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188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HXK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TCTTGGCAGCTGTTAT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TTGGTGCCTCCATCT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HXK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AGTTGAGTCCATCTTGAGTG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CCTCCTGTACTGAGGGTACT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HXK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AACTGTTGGAGCTAAGCTAA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ACTGCTGAACTTCTTGTAATG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HXK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TACCTCACATGATCTGAAAC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AATGCTCATAGAGACCACCA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HXK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ATTAGACAAGGAAAGCTT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TTTCAGCCACTATCTTTAGG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Ug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ATCTTTGAGGCTGCTC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GGATGTGCCAAGATGA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hosphoglucomut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TTTTGAGGCTACCCAT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TTATCGCCGCACACTT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188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AGPL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GGACCGTCATATAAAAG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CCATTCCAAAACAAAC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AGPS2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CAATCGAAGCGCGAG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CTGTAGTTGGCACCCA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BT1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TTGTGCATGGGTGTGA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CAGAGGAAATCGAATCCTAC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SSI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GCCTTCATGGATCAA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GCTTCAAGCATCCTCA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SSII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CAAGTACCAATGGTG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TGATGCATCTGAAACAA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SSIII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CTGCCCTGGACTACAT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AACATATGTACACGGTTCTG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GBSSI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CGTGGCTGCTCCTTG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GGCAATAAGCCACACA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BEI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GCCATGGAAGAGTTG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AAGCAACTGCTCCA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BEII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GCTAGAGTTTGACC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TGTGATGGATCCTG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ISA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CTCAGCTACTCCTCCATCA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GACCGCACAACTTCAACA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PHO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GGCAGGAAGGTTTCG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AAGCCTGAAGTGAACTTG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188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etyl-CoA carboxyl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CGCTGTAATTAGTGAGTCT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ACGCATTTATGCCTAC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pp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TCGCCGATGCTAGTGA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TGCAAAAGCCAAATA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188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itrate synth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AATCTGCCATTGGGCA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AACAACAGAAAGGAAATGAAG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onit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AATACCTTTCAAATAACCTTCT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AACGTGTGTTTAAGTGA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ADP-isocitrate dehydrogen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TTGTCGATCCAAGCAG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AAACCATCCAAATGAGG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xoglutarate dehydrogen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CAGCCTTTGCACACAT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AAACAGGTTCCTCCTC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ccinyl-CoA synthet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CCAAACTGAGCAACCAC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TCATCATAACCTATAGCCAA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DH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CGCAGGATTCCCTTC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TAAACCGCACGACAT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D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TCTTGATTTGATTTATGCTTT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TAATCCAATGTTTGTC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late dehydrogenase 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GTTGTTCTGCCCCGAT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GTTCACTGTACGCAGTT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188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ADH-ubiquinone oxidoreduct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TTGTTGCATGCTTGG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GTGGCTGTTGCATGAT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ADH-ubiquinone oxidoreductase subunit PSS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GATGCTGTTGCGGTG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CATCACTTCTATTTACACAAGTTG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tochrome b-c1 complex subunit 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TTTTCCATCGTTCCAT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ACAATTGCTTCAGTGACAG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188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zh-CN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Go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TATTTTTGGTTCTGGACA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ATAACACCACGGTCCA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S1;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GTACTTGTCCCATCCTG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ATTGGAAGCCCAGCAA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36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S1;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CCAACATGGACCCATAC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AAATGCACGGGAGAG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4400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ADH -GOG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ATAAGGCCGGGCTCAA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CAAAACGGCATTTCAC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30320"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GDH1.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GTAGTGATGAATTGCCT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CAAGAAACCAAATTCA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0" rIns="0" tIns="432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9ecf3"/>
                    </a:solidFill>
                  </a:tcPr>
                </a:tc>
              </a:tr>
            </a:tbl>
          </a:graphicData>
        </a:graphic>
      </p:graphicFrame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